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486" autoAdjust="0"/>
    <p:restoredTop sz="94660"/>
  </p:normalViewPr>
  <p:slideViewPr>
    <p:cSldViewPr snapToGrid="0">
      <p:cViewPr varScale="1">
        <p:scale>
          <a:sx n="86" d="100"/>
          <a:sy n="86" d="100"/>
        </p:scale>
        <p:origin x="1819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3BC63-C08E-4278-8EC6-44DDD49983FF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08D0C-9EC9-435A-9281-EAF7983F71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0851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3BC63-C08E-4278-8EC6-44DDD49983FF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08D0C-9EC9-435A-9281-EAF7983F71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7830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3BC63-C08E-4278-8EC6-44DDD49983FF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08D0C-9EC9-435A-9281-EAF7983F71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3460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3BC63-C08E-4278-8EC6-44DDD49983FF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08D0C-9EC9-435A-9281-EAF7983F71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0824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3BC63-C08E-4278-8EC6-44DDD49983FF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08D0C-9EC9-435A-9281-EAF7983F71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1276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3BC63-C08E-4278-8EC6-44DDD49983FF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08D0C-9EC9-435A-9281-EAF7983F71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792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3BC63-C08E-4278-8EC6-44DDD49983FF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08D0C-9EC9-435A-9281-EAF7983F71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0242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3BC63-C08E-4278-8EC6-44DDD49983FF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08D0C-9EC9-435A-9281-EAF7983F71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9191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3BC63-C08E-4278-8EC6-44DDD49983FF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08D0C-9EC9-435A-9281-EAF7983F71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6122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3BC63-C08E-4278-8EC6-44DDD49983FF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08D0C-9EC9-435A-9281-EAF7983F71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248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3BC63-C08E-4278-8EC6-44DDD49983FF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08D0C-9EC9-435A-9281-EAF7983F71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2585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3BC63-C08E-4278-8EC6-44DDD49983FF}" type="datetimeFigureOut">
              <a:rPr lang="zh-CN" altLang="en-US" smtClean="0"/>
              <a:t>2020/10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308D0C-9EC9-435A-9281-EAF7983F71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1379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0DEE0D8-AD3B-482B-89D7-DA797E313C31}"/>
              </a:ext>
            </a:extLst>
          </p:cNvPr>
          <p:cNvSpPr txBox="1"/>
          <p:nvPr/>
        </p:nvSpPr>
        <p:spPr>
          <a:xfrm>
            <a:off x="701336" y="5599328"/>
            <a:ext cx="809643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kern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Gene–metabolite correlation network representing the genes and metabolites co-enriched in KEGG pathways involved in melatonin-mediated salt tolerance. The gene–metabolite pairs are connected within the network by edges. Blue and yellow nodes indicate genes and metabolites, respectively.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A5674385-A05B-477A-BD15-7B0B810B749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38" t="8156" r="24813" b="8843"/>
          <a:stretch/>
        </p:blipFill>
        <p:spPr>
          <a:xfrm>
            <a:off x="5007006" y="361654"/>
            <a:ext cx="3227331" cy="2904597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E0FCFAD2-F35C-4914-9CB1-6778842A192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80" r="17905"/>
          <a:stretch/>
        </p:blipFill>
        <p:spPr>
          <a:xfrm>
            <a:off x="1409061" y="3393997"/>
            <a:ext cx="2561745" cy="2205331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2BF0BA0-956A-4822-95FD-5646C7E4E6A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08" t="23069" r="31933" b="23364"/>
          <a:stretch/>
        </p:blipFill>
        <p:spPr>
          <a:xfrm>
            <a:off x="5443137" y="3591750"/>
            <a:ext cx="2355067" cy="1868992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F9405316-1CB1-4E45-B7BF-6FA2778C2FF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19" t="15809" r="32039" b="22971"/>
          <a:stretch/>
        </p:blipFill>
        <p:spPr>
          <a:xfrm>
            <a:off x="1177535" y="357312"/>
            <a:ext cx="3298409" cy="2758991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5AB68A7F-BFD5-40DC-ADB1-A4FAACD0A00B}"/>
              </a:ext>
            </a:extLst>
          </p:cNvPr>
          <p:cNvSpPr txBox="1"/>
          <p:nvPr/>
        </p:nvSpPr>
        <p:spPr>
          <a:xfrm>
            <a:off x="970860" y="442873"/>
            <a:ext cx="4438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49F86FD-5812-444B-80EE-095A3CBC970D}"/>
              </a:ext>
            </a:extLst>
          </p:cNvPr>
          <p:cNvSpPr txBox="1"/>
          <p:nvPr/>
        </p:nvSpPr>
        <p:spPr>
          <a:xfrm>
            <a:off x="4857564" y="428738"/>
            <a:ext cx="4438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21E1F51-96C6-4FB9-A829-BBE50EC87E24}"/>
              </a:ext>
            </a:extLst>
          </p:cNvPr>
          <p:cNvSpPr txBox="1"/>
          <p:nvPr/>
        </p:nvSpPr>
        <p:spPr>
          <a:xfrm>
            <a:off x="955593" y="3543812"/>
            <a:ext cx="4438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99EC16C-CB46-4072-ACF1-7D9171BA523B}"/>
              </a:ext>
            </a:extLst>
          </p:cNvPr>
          <p:cNvSpPr txBox="1"/>
          <p:nvPr/>
        </p:nvSpPr>
        <p:spPr>
          <a:xfrm>
            <a:off x="4857564" y="3543812"/>
            <a:ext cx="4438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7752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8</TotalTime>
  <Words>51</Words>
  <Application>Microsoft Office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BFu-2019</dc:creator>
  <cp:lastModifiedBy>BFu-2019</cp:lastModifiedBy>
  <cp:revision>26</cp:revision>
  <cp:lastPrinted>2020-09-16T09:02:01Z</cp:lastPrinted>
  <dcterms:created xsi:type="dcterms:W3CDTF">2020-09-11T02:25:50Z</dcterms:created>
  <dcterms:modified xsi:type="dcterms:W3CDTF">2020-10-16T08:34:15Z</dcterms:modified>
</cp:coreProperties>
</file>